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2"/>
    <p:restoredTop sz="96925"/>
  </p:normalViewPr>
  <p:slideViewPr>
    <p:cSldViewPr snapToGrid="0" snapToObjects="1">
      <p:cViewPr varScale="1">
        <p:scale>
          <a:sx n="107" d="100"/>
          <a:sy n="107" d="100"/>
        </p:scale>
        <p:origin x="33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2835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3478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7101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5671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7827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9115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3779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169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4828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5364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8444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B0F623-3D13-BC48-B41D-A1556B8CA833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53DCE-4034-B64E-8CB4-99DE5B6CA6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9815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.xls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952A914F-A932-D74F-A264-813B79D5C5D0}"/>
              </a:ext>
            </a:extLst>
          </p:cNvPr>
          <p:cNvSpPr txBox="1"/>
          <p:nvPr/>
        </p:nvSpPr>
        <p:spPr>
          <a:xfrm>
            <a:off x="404767" y="234747"/>
            <a:ext cx="60026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1. Pairwise PERMANOVA on </a:t>
            </a:r>
            <a:r>
              <a:rPr lang="en-GB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pirochaeta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OTUs composition dissimilarities among localities.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437C60FB-7094-4F4B-83C9-E3AB79FB0410}"/>
              </a:ext>
            </a:extLst>
          </p:cNvPr>
          <p:cNvSpPr txBox="1"/>
          <p:nvPr/>
        </p:nvSpPr>
        <p:spPr>
          <a:xfrm>
            <a:off x="416642" y="3225829"/>
            <a:ext cx="60026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values are adjusted using the default Bonferroni method implemented in the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airwiseAdoni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R package and are considered as significant &lt; 0.05.</a:t>
            </a:r>
          </a:p>
        </p:txBody>
      </p:sp>
      <p:graphicFrame>
        <p:nvGraphicFramePr>
          <p:cNvPr id="9" name="Objet 8">
            <a:extLst>
              <a:ext uri="{FF2B5EF4-FFF2-40B4-BE49-F238E27FC236}">
                <a16:creationId xmlns:a16="http://schemas.microsoft.com/office/drawing/2014/main" id="{77E730B6-6260-8B42-8F20-3A384E5E34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0746662"/>
              </p:ext>
            </p:extLst>
          </p:nvPr>
        </p:nvGraphicFramePr>
        <p:xfrm>
          <a:off x="506680" y="696686"/>
          <a:ext cx="5900738" cy="2532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" name="Feuille de calcul" r:id="rId3" imgW="7073900" imgH="3035300" progId="Excel.Sheet.12">
                  <p:embed/>
                </p:oleObj>
              </mc:Choice>
              <mc:Fallback>
                <p:oleObj name="Feuille de calcul" r:id="rId3" imgW="7073900" imgH="3035300" progId="Excel.Sheet.12">
                  <p:embed/>
                  <p:pic>
                    <p:nvPicPr>
                      <p:cNvPr id="8" name="Objet 7">
                        <a:extLst>
                          <a:ext uri="{FF2B5EF4-FFF2-40B4-BE49-F238E27FC236}">
                            <a16:creationId xmlns:a16="http://schemas.microsoft.com/office/drawing/2014/main" id="{E092BD95-126A-1848-9DB7-683C70E2158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6680" y="696686"/>
                        <a:ext cx="5900738" cy="2532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005388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6</Words>
  <Application>Microsoft Macintosh PowerPoint</Application>
  <PresentationFormat>Format A4 (210 x 297 mm)</PresentationFormat>
  <Paragraphs>2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Feuille de calcul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laume</dc:creator>
  <cp:lastModifiedBy>Guillaume</cp:lastModifiedBy>
  <cp:revision>5</cp:revision>
  <dcterms:created xsi:type="dcterms:W3CDTF">2020-12-22T17:28:01Z</dcterms:created>
  <dcterms:modified xsi:type="dcterms:W3CDTF">2020-12-23T18:42:32Z</dcterms:modified>
</cp:coreProperties>
</file>